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C1BD28-7192-46FF-B9A4-DFA9601176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54F2A6-970A-48AA-B5A5-A86ECE9801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081CE-76CC-49AE-B998-ED0958E857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89321-FC83-4DF1-94BB-E406A24A49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5759B-0DE0-4B6A-916D-AB04E6F0EF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3CC4A-7A74-48F7-AA47-3A759470E9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510A7-5F34-41C6-BF7E-5C5BADB08C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193F3-D360-4C02-A15B-3B435D2846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FDB65-E35C-46E3-85C5-C09C94798E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B8329-72E0-43D4-B496-D4EB6017AE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F0509-09B6-4A6B-8612-ABB2D3CF14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E93A0-0290-4792-A0D0-C3FBAD1DBB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E6CE16-1E21-43D9-8FFA-9DCEF4DC6EB2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D493C4-B2ED-4792-A60C-1CAE37307E79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826920" y="1123920"/>
          <a:ext cx="6793200" cy="5200560"/>
        </p:xfrm>
        <a:graphic>
          <a:graphicData uri="http://schemas.openxmlformats.org/drawingml/2006/table">
            <a:tbl>
              <a:tblPr/>
              <a:tblGrid>
                <a:gridCol w="1698840"/>
                <a:gridCol w="1698480"/>
                <a:gridCol w="1697040"/>
                <a:gridCol w="1698840"/>
              </a:tblGrid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r>
                        <a:rPr b="1" lang="it-IT" sz="16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=0.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r>
                        <a:rPr b="1" lang="it-IT" sz="16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=0.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r>
                        <a:rPr b="1" lang="it-IT" sz="16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r>
                        <a:rPr b="1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=0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</a:t>
                      </a: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7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23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0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1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1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96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,35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2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  <a:tr h="37116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1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verag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4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000000">
                        <a:alpha val="20000"/>
                      </a:srgbClr>
                    </a:solidFill>
                  </a:tcPr>
                </a:tc>
              </a:tr>
            </a:tbl>
          </a:graphicData>
        </a:graphic>
      </p:graphicFrame>
      <p:sp>
        <p:nvSpPr>
          <p:cNvPr id="42" name="CasellaDiTesto 1"/>
          <p:cNvSpPr/>
          <p:nvPr/>
        </p:nvSpPr>
        <p:spPr>
          <a:xfrm>
            <a:off x="755640" y="260280"/>
            <a:ext cx="6912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Additional file 4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. LD decay at different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xed baselines (0.2, 0.3 and 0.5) for each chromosome (Chr) . Distance of LD decay was expressed in kb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30T08:03:32Z</dcterms:created>
  <dc:creator>adriana sacco</dc:creator>
  <dc:description/>
  <dc:language>en-US</dc:language>
  <cp:lastModifiedBy>Utente</cp:lastModifiedBy>
  <dcterms:modified xsi:type="dcterms:W3CDTF">2014-10-12T15:38:21Z</dcterms:modified>
  <cp:revision>12</cp:revision>
  <dc:subject/>
  <dc:title>Diapositiva 1</dc:title>
</cp:coreProperties>
</file>